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56" autoAdjust="0"/>
  </p:normalViewPr>
  <p:slideViewPr>
    <p:cSldViewPr>
      <p:cViewPr varScale="1">
        <p:scale>
          <a:sx n="107" d="100"/>
          <a:sy n="107" d="100"/>
        </p:scale>
        <p:origin x="-1146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C0CBD9-AC09-49EA-9CBD-FA01C4092C79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EDFF66-32FF-4C79-8D19-59A2813E822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19361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548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3033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1819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6899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3764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238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3691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0486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0113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3819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1070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BF282-B293-4320-B14F-587C2FAD3C82}" type="datetimeFigureOut">
              <a:rPr lang="fr-FR" smtClean="0"/>
              <a:t>16/01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88A4C5-FB9D-4C4D-B882-2C29CE77E8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05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79512" y="154586"/>
            <a:ext cx="8452048" cy="6226742"/>
            <a:chOff x="77693" y="154586"/>
            <a:chExt cx="8913907" cy="6730798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414" y="154586"/>
              <a:ext cx="5610964" cy="36344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451"/>
            <a:stretch/>
          </p:blipFill>
          <p:spPr bwMode="auto">
            <a:xfrm>
              <a:off x="5369748" y="154586"/>
              <a:ext cx="3621852" cy="36344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11157" y="3250930"/>
              <a:ext cx="5610964" cy="36344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3776"/>
            <a:stretch/>
          </p:blipFill>
          <p:spPr bwMode="auto">
            <a:xfrm>
              <a:off x="7524328" y="3250930"/>
              <a:ext cx="910319" cy="36344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535"/>
            <a:stretch/>
          </p:blipFill>
          <p:spPr bwMode="auto">
            <a:xfrm>
              <a:off x="77693" y="3250930"/>
              <a:ext cx="2046035" cy="36344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9" name="ZoneTexte 8"/>
          <p:cNvSpPr txBox="1"/>
          <p:nvPr/>
        </p:nvSpPr>
        <p:spPr>
          <a:xfrm>
            <a:off x="188912" y="6217567"/>
            <a:ext cx="88475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le 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kag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tis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inifera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. Cabernet-Sauvignon x 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. </a:t>
            </a:r>
            <a:r>
              <a:rPr lang="fr-F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paria</a:t>
            </a:r>
            <a:r>
              <a:rPr lang="fr-F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v.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pari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oire de Montpellier F2 population (CS x RGM_F2). Linkage groups (LG) ar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m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ord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international consensus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p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istances are i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ntiMorgan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sambi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1277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0</TotalTime>
  <Words>51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abine</dc:creator>
  <cp:lastModifiedBy>Sabine</cp:lastModifiedBy>
  <cp:revision>82</cp:revision>
  <dcterms:created xsi:type="dcterms:W3CDTF">2016-03-30T14:19:26Z</dcterms:created>
  <dcterms:modified xsi:type="dcterms:W3CDTF">2020-01-16T09:23:22Z</dcterms:modified>
</cp:coreProperties>
</file>